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27BC69-4DE8-47A6-A39C-73BCCEEC1B9C}" v="2" dt="2026-03-31T01:53:05.86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23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88b1893c-db63-4bb5-9dca-a6ce3447aab8" providerId="ADAL" clId="{4C98BF49-9253-44F8-8335-0E5DA0562794}"/>
    <pc:docChg chg="custSel modSld">
      <pc:chgData name="辰巳　めぐみ" userId="88b1893c-db63-4bb5-9dca-a6ce3447aab8" providerId="ADAL" clId="{4C98BF49-9253-44F8-8335-0E5DA0562794}" dt="2026-03-25T03:12:03.605" v="373" actId="478"/>
      <pc:docMkLst>
        <pc:docMk/>
      </pc:docMkLst>
      <pc:sldChg chg="addSp delSp modSp mod">
        <pc:chgData name="辰巳　めぐみ" userId="88b1893c-db63-4bb5-9dca-a6ce3447aab8" providerId="ADAL" clId="{4C98BF49-9253-44F8-8335-0E5DA0562794}" dt="2026-03-25T03:12:03.605" v="373" actId="478"/>
        <pc:sldMkLst>
          <pc:docMk/>
          <pc:sldMk cId="3285713202" sldId="256"/>
        </pc:sldMkLst>
        <pc:picChg chg="add mod ord">
          <ac:chgData name="辰巳　めぐみ" userId="88b1893c-db63-4bb5-9dca-a6ce3447aab8" providerId="ADAL" clId="{4C98BF49-9253-44F8-8335-0E5DA0562794}" dt="2026-03-25T03:07:40.616" v="322" actId="1038"/>
          <ac:picMkLst>
            <pc:docMk/>
            <pc:sldMk cId="3285713202" sldId="256"/>
            <ac:picMk id="2" creationId="{DE2D2601-3CBB-2940-A39E-8FA681E69AF4}"/>
          </ac:picMkLst>
        </pc:picChg>
        <pc:picChg chg="add mod ord">
          <ac:chgData name="辰巳　めぐみ" userId="88b1893c-db63-4bb5-9dca-a6ce3447aab8" providerId="ADAL" clId="{4C98BF49-9253-44F8-8335-0E5DA0562794}" dt="2026-03-25T03:07:18.781" v="319" actId="1076"/>
          <ac:picMkLst>
            <pc:docMk/>
            <pc:sldMk cId="3285713202" sldId="256"/>
            <ac:picMk id="3" creationId="{BB497099-84A6-D9CB-2D7B-FFA4F34680E1}"/>
          </ac:picMkLst>
        </pc:picChg>
        <pc:picChg chg="add mod ord">
          <ac:chgData name="辰巳　めぐみ" userId="88b1893c-db63-4bb5-9dca-a6ce3447aab8" providerId="ADAL" clId="{4C98BF49-9253-44F8-8335-0E5DA0562794}" dt="2026-03-25T03:07:40.616" v="322" actId="1038"/>
          <ac:picMkLst>
            <pc:docMk/>
            <pc:sldMk cId="3285713202" sldId="256"/>
            <ac:picMk id="13" creationId="{7DB3B715-CF63-93C6-FBB1-21964BF78E6A}"/>
          </ac:picMkLst>
        </pc:picChg>
        <pc:picChg chg="add mod ord">
          <ac:chgData name="辰巳　めぐみ" userId="88b1893c-db63-4bb5-9dca-a6ce3447aab8" providerId="ADAL" clId="{4C98BF49-9253-44F8-8335-0E5DA0562794}" dt="2026-03-25T03:11:41.368" v="362" actId="1037"/>
          <ac:picMkLst>
            <pc:docMk/>
            <pc:sldMk cId="3285713202" sldId="256"/>
            <ac:picMk id="15" creationId="{950B0719-946C-C2FC-BA21-D2C426A1BF78}"/>
          </ac:picMkLst>
        </pc:picChg>
        <pc:picChg chg="add mod ord">
          <ac:chgData name="辰巳　めぐみ" userId="88b1893c-db63-4bb5-9dca-a6ce3447aab8" providerId="ADAL" clId="{4C98BF49-9253-44F8-8335-0E5DA0562794}" dt="2026-03-25T03:12:01.164" v="372" actId="167"/>
          <ac:picMkLst>
            <pc:docMk/>
            <pc:sldMk cId="3285713202" sldId="256"/>
            <ac:picMk id="16" creationId="{EE1D9F6A-64F1-8557-CABD-2F5714604B82}"/>
          </ac:picMkLst>
        </pc:picChg>
        <pc:picChg chg="add mod ord">
          <ac:chgData name="辰巳　めぐみ" userId="88b1893c-db63-4bb5-9dca-a6ce3447aab8" providerId="ADAL" clId="{4C98BF49-9253-44F8-8335-0E5DA0562794}" dt="2026-03-25T03:11:15.162" v="349" actId="1076"/>
          <ac:picMkLst>
            <pc:docMk/>
            <pc:sldMk cId="3285713202" sldId="256"/>
            <ac:picMk id="17" creationId="{E22FF029-DED6-856C-4A8B-7F99C8F35789}"/>
          </ac:picMkLst>
        </pc:picChg>
      </pc:sldChg>
    </pc:docChg>
  </pc:docChgLst>
  <pc:docChgLst>
    <pc:chgData name="辰巳　めぐみ" userId="S::megumi_tatsumi@ncnp.go.jp::88b1893c-db63-4bb5-9dca-a6ce3447aab8" providerId="AD" clId="Web-{1127BC69-4DE8-47A6-A39C-73BCCEEC1B9C}"/>
    <pc:docChg chg="modSld">
      <pc:chgData name="辰巳　めぐみ" userId="S::megumi_tatsumi@ncnp.go.jp::88b1893c-db63-4bb5-9dca-a6ce3447aab8" providerId="AD" clId="Web-{1127BC69-4DE8-47A6-A39C-73BCCEEC1B9C}" dt="2026-03-31T01:53:05.850" v="0" actId="20577"/>
      <pc:docMkLst>
        <pc:docMk/>
      </pc:docMkLst>
      <pc:sldChg chg="modSp">
        <pc:chgData name="辰巳　めぐみ" userId="S::megumi_tatsumi@ncnp.go.jp::88b1893c-db63-4bb5-9dca-a6ce3447aab8" providerId="AD" clId="Web-{1127BC69-4DE8-47A6-A39C-73BCCEEC1B9C}" dt="2026-03-31T01:53:05.850" v="0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1127BC69-4DE8-47A6-A39C-73BCCEEC1B9C}" dt="2026-03-31T01:53:05.850" v="0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EE1D9F6A-64F1-8557-CABD-2F5714604B82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784199" y="2691265"/>
            <a:ext cx="2052000" cy="2052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50B0719-946C-C2FC-BA21-D2C426A1BF78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000389" y="420031"/>
            <a:ext cx="2052000" cy="2052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E22FF029-DED6-856C-4A8B-7F99C8F3578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774917" y="423491"/>
            <a:ext cx="2052000" cy="2052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DB3B715-CF63-93C6-FBB1-21964BF78E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1157" y="2678828"/>
            <a:ext cx="2052000" cy="2045068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B497099-84A6-D9CB-2D7B-FFA4F34680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3905" y="426952"/>
            <a:ext cx="2052000" cy="2045079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DE2D2601-3CBB-2940-A39E-8FA681E69AF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4460" y="436292"/>
            <a:ext cx="2052000" cy="204506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921365"/>
            <a:ext cx="6854109" cy="52322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>
                <a:latin typeface="Times"/>
                <a:ea typeface="游明朝"/>
                <a:cs typeface="Times New Roman"/>
              </a:rPr>
              <a:t>S13</a:t>
            </a: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 dirty="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freeze–thaw cycles on CSF and plasma proteomes analyzed by volcano plots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FFD0BE5-B517-78B9-DB1E-80894385E8F2}"/>
              </a:ext>
            </a:extLst>
          </p:cNvPr>
          <p:cNvSpPr txBox="1"/>
          <p:nvPr/>
        </p:nvSpPr>
        <p:spPr>
          <a:xfrm>
            <a:off x="309399" y="4228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74BBBB4-8D59-7964-E33E-0DB2BE7AF7E0}"/>
              </a:ext>
            </a:extLst>
          </p:cNvPr>
          <p:cNvSpPr txBox="1"/>
          <p:nvPr/>
        </p:nvSpPr>
        <p:spPr>
          <a:xfrm>
            <a:off x="4831497" y="4228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A6B4118-272C-A989-C7F5-FFB4FD91487F}"/>
              </a:ext>
            </a:extLst>
          </p:cNvPr>
          <p:cNvSpPr txBox="1"/>
          <p:nvPr/>
        </p:nvSpPr>
        <p:spPr>
          <a:xfrm>
            <a:off x="701632" y="2374296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DD75612-4108-A872-9FA0-DA6F2EB453EC}"/>
              </a:ext>
            </a:extLst>
          </p:cNvPr>
          <p:cNvSpPr txBox="1"/>
          <p:nvPr/>
        </p:nvSpPr>
        <p:spPr>
          <a:xfrm>
            <a:off x="2930975" y="2369325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9155712-F1EC-0B51-D155-7F7B31FED988}"/>
              </a:ext>
            </a:extLst>
          </p:cNvPr>
          <p:cNvSpPr txBox="1"/>
          <p:nvPr/>
        </p:nvSpPr>
        <p:spPr>
          <a:xfrm>
            <a:off x="5258369" y="2364700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7753A45-B35B-DA05-FC87-7D01419B0443}"/>
              </a:ext>
            </a:extLst>
          </p:cNvPr>
          <p:cNvSpPr txBox="1"/>
          <p:nvPr/>
        </p:nvSpPr>
        <p:spPr>
          <a:xfrm rot="16200000">
            <a:off x="-395467" y="1349163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5B0A8B4-4BA8-D161-69BB-6AAB6D8CE65A}"/>
              </a:ext>
            </a:extLst>
          </p:cNvPr>
          <p:cNvSpPr txBox="1"/>
          <p:nvPr/>
        </p:nvSpPr>
        <p:spPr>
          <a:xfrm rot="16200000">
            <a:off x="1828913" y="1346400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8B8F70C-AE4A-3AFC-1C19-08F54C6551D3}"/>
              </a:ext>
            </a:extLst>
          </p:cNvPr>
          <p:cNvSpPr txBox="1"/>
          <p:nvPr/>
        </p:nvSpPr>
        <p:spPr>
          <a:xfrm rot="16200000">
            <a:off x="4187201" y="1346400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C90F744-CFEB-F6A6-47DB-663D4D647986}"/>
              </a:ext>
            </a:extLst>
          </p:cNvPr>
          <p:cNvSpPr txBox="1"/>
          <p:nvPr/>
        </p:nvSpPr>
        <p:spPr>
          <a:xfrm>
            <a:off x="701632" y="4612460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25B34C8-0935-CA14-3ACD-F573245D5008}"/>
              </a:ext>
            </a:extLst>
          </p:cNvPr>
          <p:cNvSpPr txBox="1"/>
          <p:nvPr/>
        </p:nvSpPr>
        <p:spPr>
          <a:xfrm>
            <a:off x="5258368" y="4658672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CC1B5DC-A30B-123E-F8E7-7E6058B6FAF4}"/>
              </a:ext>
            </a:extLst>
          </p:cNvPr>
          <p:cNvSpPr txBox="1"/>
          <p:nvPr/>
        </p:nvSpPr>
        <p:spPr>
          <a:xfrm rot="16200000">
            <a:off x="-358572" y="3590500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301D93B-F32B-7CDB-ABE9-A16FA3A1DE03}"/>
              </a:ext>
            </a:extLst>
          </p:cNvPr>
          <p:cNvSpPr txBox="1"/>
          <p:nvPr/>
        </p:nvSpPr>
        <p:spPr>
          <a:xfrm rot="16200000">
            <a:off x="4187200" y="3596301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A05560C-C9BE-1B48-12E1-B679885B8AD9}"/>
              </a:ext>
            </a:extLst>
          </p:cNvPr>
          <p:cNvSpPr txBox="1"/>
          <p:nvPr/>
        </p:nvSpPr>
        <p:spPr>
          <a:xfrm>
            <a:off x="7476052" y="2401316"/>
            <a:ext cx="1241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FD4E3C2-3B3B-FB67-F3C0-56DDDE4DF56D}"/>
              </a:ext>
            </a:extLst>
          </p:cNvPr>
          <p:cNvSpPr txBox="1"/>
          <p:nvPr/>
        </p:nvSpPr>
        <p:spPr>
          <a:xfrm rot="16200000">
            <a:off x="6404884" y="1338945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05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F7BD3B3-9094-4600-98DE-CC4595C5B835}">
  <ds:schemaRefs>
    <ds:schemaRef ds:uri="09e658bc-5f5e-48b2-a593-8f2a4dff4e86"/>
    <ds:schemaRef ds:uri="http://purl.org/dc/terms/"/>
    <ds:schemaRef ds:uri="http://schemas.microsoft.com/office/2006/metadata/properties"/>
    <ds:schemaRef ds:uri="http://purl.org/dc/elements/1.1/"/>
    <ds:schemaRef ds:uri="http://www.w3.org/XML/1998/namespace"/>
    <ds:schemaRef ds:uri="http://schemas.microsoft.com/office/2006/documentManagement/types"/>
    <ds:schemaRef ds:uri="http://schemas.openxmlformats.org/package/2006/metadata/core-properties"/>
    <ds:schemaRef ds:uri="http://schemas.microsoft.com/office/infopath/2007/PartnerControl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77E09909-6CFD-4D06-ADAD-773345ACC4D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5B90841-1672-4B01-964A-D471921F43F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0</TotalTime>
  <Words>57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11</cp:revision>
  <dcterms:created xsi:type="dcterms:W3CDTF">2025-03-28T03:13:18Z</dcterms:created>
  <dcterms:modified xsi:type="dcterms:W3CDTF">2026-03-31T01:53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